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3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-372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FC78629F-EE16-4C7A-A4C1-D387824A7D6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xmlns="" id="{D9F42254-8ABD-4007-9D46-FA81ED36B6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xmlns="" id="{838C0ABE-174E-4737-ADC7-45D6B8AA30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A2D08-0EDD-4DB8-8EFE-BFE7DB6E43BF}" type="datetimeFigureOut">
              <a:rPr lang="pt-BR" smtClean="0"/>
              <a:t>16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xmlns="" id="{BAF2C916-81A8-4425-84E9-C076216F61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xmlns="" id="{B53A5506-3E66-48AC-A6B5-62DF4DDCE5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A599-CBF3-4244-9855-49FB75CD40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996970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DC6018DA-0956-4680-8A50-0A4A3CE4E0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xmlns="" id="{45C00EE9-7CD4-4AE0-9B8F-1E91CAD7C3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xmlns="" id="{27461E0C-7321-4758-B706-6235878F6F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A2D08-0EDD-4DB8-8EFE-BFE7DB6E43BF}" type="datetimeFigureOut">
              <a:rPr lang="pt-BR" smtClean="0"/>
              <a:t>16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xmlns="" id="{50356816-3525-4D6E-94B0-A78FA7A86E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xmlns="" id="{9EF893F3-9ADF-4F59-A894-29DE4A7E33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A599-CBF3-4244-9855-49FB75CD40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4402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xmlns="" id="{2A78678E-0DBD-44F1-A012-224B1CB9FA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xmlns="" id="{A39C52E1-9558-4231-9DB7-EA43B9CF3D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xmlns="" id="{BB81B661-5BD4-4A7C-BBD6-ED0DC4AF42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A2D08-0EDD-4DB8-8EFE-BFE7DB6E43BF}" type="datetimeFigureOut">
              <a:rPr lang="pt-BR" smtClean="0"/>
              <a:t>16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xmlns="" id="{10C2942B-65E4-477E-97B6-AD84544960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xmlns="" id="{D13DD8A7-FA7D-4492-8D39-70FDE1BCC1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A599-CBF3-4244-9855-49FB75CD40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805978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A5EB72E2-5D1C-4C23-942A-DE03CB30ED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xmlns="" id="{FADBC14E-9541-4546-8432-A328970F40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xmlns="" id="{040E0E22-6DE5-424D-879D-ABCA4E2A2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A2D08-0EDD-4DB8-8EFE-BFE7DB6E43BF}" type="datetimeFigureOut">
              <a:rPr lang="pt-BR" smtClean="0"/>
              <a:t>16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xmlns="" id="{60F73B51-3E60-40A7-B9D4-CDD75E1EBD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xmlns="" id="{F91B1FA4-4EC4-4399-AB17-3299290CAB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A599-CBF3-4244-9855-49FB75CD40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69198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69CC2052-C82C-47AE-868A-CE9151AB14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xmlns="" id="{F7312431-B7ED-41BC-A052-A3001D3622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xmlns="" id="{E109417D-38E8-4909-B00F-A5A2565ED6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A2D08-0EDD-4DB8-8EFE-BFE7DB6E43BF}" type="datetimeFigureOut">
              <a:rPr lang="pt-BR" smtClean="0"/>
              <a:t>16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xmlns="" id="{448DAF18-F4ED-4F17-9FFC-86C15FA7FE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xmlns="" id="{8DEBAD42-B6A0-4259-998F-39B47DAB11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A599-CBF3-4244-9855-49FB75CD40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36429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D5B1ADBB-E97E-45D5-A167-C99D2DB868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xmlns="" id="{2DF5005E-395A-4E55-9896-59B4F804B2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xmlns="" id="{F066F0FB-FD6B-47E3-A163-F611579370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xmlns="" id="{1E73B6BF-F479-4A50-BCC7-0DEFA6E769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A2D08-0EDD-4DB8-8EFE-BFE7DB6E43BF}" type="datetimeFigureOut">
              <a:rPr lang="pt-BR" smtClean="0"/>
              <a:t>16/03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xmlns="" id="{2F79208C-F6E5-4223-B9F5-23C12EFBA0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xmlns="" id="{2ECE61BF-CAEB-44E0-AE21-EC6654F96D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A599-CBF3-4244-9855-49FB75CD40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958219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86C2F479-DDAA-43EF-A92C-4D5240A8E5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xmlns="" id="{9F6BFC5D-FE48-4F6E-9845-2F27E0A650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xmlns="" id="{21521DB0-F5B5-4EB3-B687-09477B480E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xmlns="" id="{0C49853D-0325-4E70-8E5F-2753A1AF33C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xmlns="" id="{DC4B32BF-6526-4920-840B-3B1D19BEE06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xmlns="" id="{84D816A6-AECF-4E26-9A7C-76EE186059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A2D08-0EDD-4DB8-8EFE-BFE7DB6E43BF}" type="datetimeFigureOut">
              <a:rPr lang="pt-BR" smtClean="0"/>
              <a:t>16/03/2022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xmlns="" id="{8D5EB91A-64CD-4A92-B294-695B109A0D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xmlns="" id="{7901AB1D-B266-4D4E-882F-A5B8EF0A04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A599-CBF3-4244-9855-49FB75CD40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37399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20169BC5-01DB-4489-92D4-7EDDE94397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xmlns="" id="{FDAC53D1-12AF-4E85-8077-80359B7CC2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A2D08-0EDD-4DB8-8EFE-BFE7DB6E43BF}" type="datetimeFigureOut">
              <a:rPr lang="pt-BR" smtClean="0"/>
              <a:t>16/03/2022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xmlns="" id="{CC861EC3-D65A-4C58-9547-3CBAC9266E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xmlns="" id="{8774D9C5-9D9E-41FC-BE0E-6ED10E5F64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A599-CBF3-4244-9855-49FB75CD40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956857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xmlns="" id="{C5A7F1BA-9479-4E3B-B764-9FD362EE7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A2D08-0EDD-4DB8-8EFE-BFE7DB6E43BF}" type="datetimeFigureOut">
              <a:rPr lang="pt-BR" smtClean="0"/>
              <a:t>16/03/2022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xmlns="" id="{B7E98801-4216-4585-AD70-EF1BD874D1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xmlns="" id="{70454680-4513-47A0-9FA1-32CD9B7B5A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A599-CBF3-4244-9855-49FB75CD40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00863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5AC89ECA-6193-44B7-B457-401ED333FD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xmlns="" id="{F8CA9344-6AFE-4DFB-9FBC-9FB59B58FC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xmlns="" id="{218BE544-8C81-4489-A9DD-5467C3EDC3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xmlns="" id="{828A4EDC-CC56-45D5-BC54-D9BDF11161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A2D08-0EDD-4DB8-8EFE-BFE7DB6E43BF}" type="datetimeFigureOut">
              <a:rPr lang="pt-BR" smtClean="0"/>
              <a:t>16/03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xmlns="" id="{4ED5D385-03B6-425A-B806-26B7E8D398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xmlns="" id="{6EEA4981-662D-4844-9836-5A7D22F38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A599-CBF3-4244-9855-49FB75CD40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279325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A4A57CAE-748C-477A-9620-99FE5E6294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xmlns="" id="{20C4CF27-2C7B-4B74-8C0B-BEA2817834F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xmlns="" id="{1C0CCA45-A627-49E4-A711-8DDEA0E90E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xmlns="" id="{AAC89D76-C83A-4290-A064-C0207C58AE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A2D08-0EDD-4DB8-8EFE-BFE7DB6E43BF}" type="datetimeFigureOut">
              <a:rPr lang="pt-BR" smtClean="0"/>
              <a:t>16/03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xmlns="" id="{CACA805F-2F7D-4CBF-A5A8-39C1E3B20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xmlns="" id="{05DAD8EC-9078-4498-AD30-D53FCB7EF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A599-CBF3-4244-9855-49FB75CD40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45493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xmlns="" id="{A7715B8C-78B6-4FF5-A7DE-F8CE538A21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xmlns="" id="{05B592B5-61F0-4584-ACB2-6D8A2ADE30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xmlns="" id="{380BC8C5-411D-467B-8C04-CAEB0698F0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8A2D08-0EDD-4DB8-8EFE-BFE7DB6E43BF}" type="datetimeFigureOut">
              <a:rPr lang="pt-BR" smtClean="0"/>
              <a:t>16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xmlns="" id="{6901849D-E59B-45C1-B79B-31D4D4F7F5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xmlns="" id="{F97C8B78-D083-4506-ADC6-FFEDC1C3C5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E9A599-CBF3-4244-9855-49FB75CD40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261999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m 2">
            <a:extLst>
              <a:ext uri="{FF2B5EF4-FFF2-40B4-BE49-F238E27FC236}">
                <a16:creationId xmlns:a16="http://schemas.microsoft.com/office/drawing/2014/main" xmlns="" id="{85D3412E-18E5-4E20-994A-A1CE9B9EB70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77270"/>
            <a:ext cx="12192000" cy="6103459"/>
          </a:xfrm>
          <a:prstGeom prst="rect">
            <a:avLst/>
          </a:prstGeom>
        </p:spPr>
      </p:pic>
      <p:sp>
        <p:nvSpPr>
          <p:cNvPr id="2" name="1 Rectángulo"/>
          <p:cNvSpPr/>
          <p:nvPr/>
        </p:nvSpPr>
        <p:spPr>
          <a:xfrm>
            <a:off x="6096000" y="5599964"/>
            <a:ext cx="6096000" cy="461665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tic linkage map of tomato, constructed based on an F7 IBL population of the cross between E6203xLA1589 and 551 SNPs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988342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6</TotalTime>
  <Words>26</Words>
  <Application>Microsoft Office PowerPoint</Application>
  <PresentationFormat>Personalizado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o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Luciano Maia</dc:creator>
  <cp:lastModifiedBy>Maria Jose Gonzalo Pascual</cp:lastModifiedBy>
  <cp:revision>11</cp:revision>
  <dcterms:created xsi:type="dcterms:W3CDTF">2021-08-27T17:25:25Z</dcterms:created>
  <dcterms:modified xsi:type="dcterms:W3CDTF">2022-03-16T13:55:51Z</dcterms:modified>
</cp:coreProperties>
</file>